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936" userDrawn="1">
          <p15:clr>
            <a:srgbClr val="A4A3A4"/>
          </p15:clr>
        </p15:guide>
        <p15:guide id="2" pos="470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118" d="100"/>
          <a:sy n="118" d="100"/>
        </p:scale>
        <p:origin x="576" y="96"/>
      </p:cViewPr>
      <p:guideLst>
        <p:guide orient="horz" pos="3936"/>
        <p:guide pos="47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14FFA6-7D6A-CD1B-FF62-902CF0BBB96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603AD42-C47E-65AE-885B-54315065B4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D5D828-53E1-E067-7A8F-660D854310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24B49-7751-4425-B5DA-D50E117B5064}" type="datetimeFigureOut">
              <a:rPr lang="en-US" smtClean="0"/>
              <a:t>5/3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D772C2-0378-5C41-DB20-F2AFAAFFD7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3D4458-D65F-6E18-F147-BE813E48F2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5338A-1542-4913-9E9C-B4CD9A582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354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F2D99F-270D-8AE9-27C0-3620E16D85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7025D4E-7EB8-B2B1-B3A6-A949EAF0A1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156026-E965-CD55-D358-0031BD3A00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24B49-7751-4425-B5DA-D50E117B5064}" type="datetimeFigureOut">
              <a:rPr lang="en-US" smtClean="0"/>
              <a:t>5/3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D20C5E-B7B3-8B6A-308F-F1EDA577A6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C5792E-3E3F-D8A8-FF05-36B84D168A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5338A-1542-4913-9E9C-B4CD9A582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53738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4EC38DB-E91A-3100-02C7-6F8132F71D2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A5C8EEF-A3CD-EF55-A4E6-DDD66F49D4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D349C1-F650-E7DF-155A-D6D798077F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24B49-7751-4425-B5DA-D50E117B5064}" type="datetimeFigureOut">
              <a:rPr lang="en-US" smtClean="0"/>
              <a:t>5/3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6AB6DA-A590-9EFF-D372-D2CBAD4328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7C11D5-891B-71CC-B6FF-03CA106459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5338A-1542-4913-9E9C-B4CD9A582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38694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793E7C-FA71-B9BC-B152-24975DAA88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0978C4-C96A-0AC9-797D-BF200B26DAB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EE6F04-4781-B212-FAA4-11E6FF9668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24B49-7751-4425-B5DA-D50E117B5064}" type="datetimeFigureOut">
              <a:rPr lang="en-US" smtClean="0"/>
              <a:t>5/3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D1852C-F32E-683F-9B19-4D4E2D514D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9DBF36-C570-306B-CA93-33A2AF980B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5338A-1542-4913-9E9C-B4CD9A582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16332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AEC5E9-134D-B43B-33DA-E2C727F23D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5DEF24-49C3-96B1-BF0B-1B3BA821C4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0F0459-95CA-50C0-60AF-09728FE346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24B49-7751-4425-B5DA-D50E117B5064}" type="datetimeFigureOut">
              <a:rPr lang="en-US" smtClean="0"/>
              <a:t>5/3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C7D220-E2FE-DEA9-FC5F-23012F0D7B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C2DFC5-0778-66F9-DA28-9FC7CC831B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5338A-1542-4913-9E9C-B4CD9A582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8514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3CFF0D-9A57-5CB2-2A2C-B35CF72E9B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BA655B-0506-D5CC-2477-AB16A3F74B9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47C291A-58B6-FAC3-5EBE-CD15CAC0D1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9DD97C-D9C4-FD35-AB7F-6AA3C7231E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24B49-7751-4425-B5DA-D50E117B5064}" type="datetimeFigureOut">
              <a:rPr lang="en-US" smtClean="0"/>
              <a:t>5/3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65C1BD-9A63-3E51-0C31-97A6CA2F1C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E0A7C9-BF0C-7BE1-5173-7929399B15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5338A-1542-4913-9E9C-B4CD9A582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7089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061380-F28E-D76C-E36F-B0B5989651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8B009B-2AEF-041F-340D-C984D1B685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2B55781-4593-DBF7-F88F-788C3E2B7D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B2D0491-4A5B-6601-2A5A-1800B2EC061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B6F7A6C-BB15-40FE-5E16-E9170B30337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BD0C809-2F17-4D97-B08E-41CB818412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24B49-7751-4425-B5DA-D50E117B5064}" type="datetimeFigureOut">
              <a:rPr lang="en-US" smtClean="0"/>
              <a:t>5/3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A47E89A-0210-2329-81E1-55C84EB46A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4153E45-4E67-F414-9D31-7DB2D49F81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5338A-1542-4913-9E9C-B4CD9A582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9607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937FE8-94AF-F43F-417F-F3CBCF5E88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D354451-825F-7EBF-2ED5-22EC99203E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24B49-7751-4425-B5DA-D50E117B5064}" type="datetimeFigureOut">
              <a:rPr lang="en-US" smtClean="0"/>
              <a:t>5/3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36FC30D-13CA-5AE4-988C-F30E1F2831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6028AA6-FFCB-3C7C-FCB2-BE2C4C99EA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5338A-1542-4913-9E9C-B4CD9A582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9433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BF6A604-368F-519E-AA9C-74839C8A5D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24B49-7751-4425-B5DA-D50E117B5064}" type="datetimeFigureOut">
              <a:rPr lang="en-US" smtClean="0"/>
              <a:t>5/3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36ABFE4-9932-7AD9-D8F7-41CACAEAE3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0D9DC9A-87C7-8DCC-0DD0-D6B828F2B3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5338A-1542-4913-9E9C-B4CD9A582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1549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3C4BE9-497B-6BF7-D1DE-B0F44384A4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662276-2C04-0DB2-E2F5-460E6B1559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70BC1D2-32F6-43C5-14A3-9A636F4BAF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6D905E-1422-8875-EA59-4B5DECC63E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24B49-7751-4425-B5DA-D50E117B5064}" type="datetimeFigureOut">
              <a:rPr lang="en-US" smtClean="0"/>
              <a:t>5/3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A3A74A-3D17-2F39-B21D-E7F5F768B5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7D9F7B8-F8CC-5FD2-1D95-564DC41A8E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5338A-1542-4913-9E9C-B4CD9A582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2507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4DE91D-8B4D-7423-BCF0-277C5B5BED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AA4DBE5-83E3-C3EC-6A67-F02BA0BD403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920CC48-BA81-B8A3-E665-28C525DE20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AF8050-5A53-9441-34E5-ED5FD319DB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324B49-7751-4425-B5DA-D50E117B5064}" type="datetimeFigureOut">
              <a:rPr lang="en-US" smtClean="0"/>
              <a:t>5/3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94B87F-527A-9200-9768-5E703E9CC2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AF08EF-C38B-0D09-7B24-3B59D3EDCF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5338A-1542-4913-9E9C-B4CD9A582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59912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8AFDBA5-879C-55DC-D3AC-20E1ECC565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6F63AF-5EA9-6F27-2AA0-AE10EDCFED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B97B51-FA56-374E-8CCC-DD60C25BD54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324B49-7751-4425-B5DA-D50E117B5064}" type="datetimeFigureOut">
              <a:rPr lang="en-US" smtClean="0"/>
              <a:t>5/3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697AEA-CF50-AC33-100D-711014502BE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DDA9EA-AF54-7C19-A3AD-37056787781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F5338A-1542-4913-9E9C-B4CD9A5824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10871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E49F01E-4AEB-81C5-7214-E55D4ABAB58F}"/>
              </a:ext>
            </a:extLst>
          </p:cNvPr>
          <p:cNvSpPr txBox="1"/>
          <p:nvPr/>
        </p:nvSpPr>
        <p:spPr>
          <a:xfrm>
            <a:off x="385482" y="98611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1</a:t>
            </a:r>
          </a:p>
        </p:txBody>
      </p:sp>
      <p:pic>
        <p:nvPicPr>
          <p:cNvPr id="6" name="Picture 5" descr="A picture containing text, whiteboard&#10;&#10;Description automatically generated">
            <a:extLst>
              <a:ext uri="{FF2B5EF4-FFF2-40B4-BE49-F238E27FC236}">
                <a16:creationId xmlns:a16="http://schemas.microsoft.com/office/drawing/2014/main" id="{916BE3E3-89D4-C441-2201-83E01D439E7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882" t="5643" r="21896" b="5992"/>
          <a:stretch/>
        </p:blipFill>
        <p:spPr>
          <a:xfrm>
            <a:off x="4572000" y="959219"/>
            <a:ext cx="2895600" cy="4545106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45CE59E-2FDA-BC0B-75FD-7F0443625B08}"/>
              </a:ext>
            </a:extLst>
          </p:cNvPr>
          <p:cNvSpPr txBox="1"/>
          <p:nvPr/>
        </p:nvSpPr>
        <p:spPr>
          <a:xfrm>
            <a:off x="4940915" y="700150"/>
            <a:ext cx="59413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u="sng" dirty="0"/>
              <a:t>Xyl3C</a:t>
            </a:r>
            <a:endParaRPr lang="en-US" sz="1400" dirty="0"/>
          </a:p>
          <a:p>
            <a:pPr algn="ctr"/>
            <a:r>
              <a:rPr lang="en-US" sz="1400" dirty="0"/>
              <a:t>4ug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C499C1E-3B70-0666-8D5B-3C5F65D1C720}"/>
              </a:ext>
            </a:extLst>
          </p:cNvPr>
          <p:cNvSpPr txBox="1"/>
          <p:nvPr/>
        </p:nvSpPr>
        <p:spPr>
          <a:xfrm>
            <a:off x="5681782" y="700148"/>
            <a:ext cx="60054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u="sng" dirty="0"/>
              <a:t>Xyl3B</a:t>
            </a:r>
            <a:endParaRPr lang="en-US" sz="1400" dirty="0"/>
          </a:p>
          <a:p>
            <a:pPr algn="ctr"/>
            <a:r>
              <a:rPr lang="en-US" sz="1400" dirty="0"/>
              <a:t>4u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A863B74-2520-2E25-7C6E-D1694EB924C6}"/>
              </a:ext>
            </a:extLst>
          </p:cNvPr>
          <p:cNvSpPr txBox="1"/>
          <p:nvPr/>
        </p:nvSpPr>
        <p:spPr>
          <a:xfrm>
            <a:off x="6372359" y="691183"/>
            <a:ext cx="4984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u="sng" dirty="0" err="1"/>
              <a:t>Stds</a:t>
            </a:r>
            <a:endParaRPr lang="en-US" sz="1400" b="1" u="sng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F0524C2-BC5A-F5C1-2006-6AB779275AF2}"/>
              </a:ext>
            </a:extLst>
          </p:cNvPr>
          <p:cNvSpPr txBox="1"/>
          <p:nvPr/>
        </p:nvSpPr>
        <p:spPr>
          <a:xfrm>
            <a:off x="7034620" y="1121488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25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8F2D8AD-CB37-E607-BEDE-1FCDBF3F8E28}"/>
              </a:ext>
            </a:extLst>
          </p:cNvPr>
          <p:cNvSpPr txBox="1"/>
          <p:nvPr/>
        </p:nvSpPr>
        <p:spPr>
          <a:xfrm>
            <a:off x="7034620" y="1591534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15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054A905-CA8A-0DE5-661D-0F3A904B2A05}"/>
              </a:ext>
            </a:extLst>
          </p:cNvPr>
          <p:cNvSpPr txBox="1"/>
          <p:nvPr/>
        </p:nvSpPr>
        <p:spPr>
          <a:xfrm>
            <a:off x="7025656" y="2026923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10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5B7EAD0-F463-CFB7-282C-9D9A22719AFC}"/>
              </a:ext>
            </a:extLst>
          </p:cNvPr>
          <p:cNvSpPr txBox="1"/>
          <p:nvPr/>
        </p:nvSpPr>
        <p:spPr>
          <a:xfrm>
            <a:off x="7125130" y="235861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7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2052C41-2038-F33C-4088-E1823E7F8741}"/>
              </a:ext>
            </a:extLst>
          </p:cNvPr>
          <p:cNvSpPr txBox="1"/>
          <p:nvPr/>
        </p:nvSpPr>
        <p:spPr>
          <a:xfrm>
            <a:off x="7125130" y="286960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5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B27E893-2CDF-1EEF-7DD3-338E49F44971}"/>
              </a:ext>
            </a:extLst>
          </p:cNvPr>
          <p:cNvSpPr txBox="1"/>
          <p:nvPr/>
        </p:nvSpPr>
        <p:spPr>
          <a:xfrm>
            <a:off x="7125130" y="3281984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37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B441D09-DDCE-CD7F-8473-0FC978DE1143}"/>
              </a:ext>
            </a:extLst>
          </p:cNvPr>
          <p:cNvSpPr txBox="1"/>
          <p:nvPr/>
        </p:nvSpPr>
        <p:spPr>
          <a:xfrm>
            <a:off x="7125128" y="388261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25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9D323A5-D3A4-0748-9BFB-97EC95C7C8DF}"/>
              </a:ext>
            </a:extLst>
          </p:cNvPr>
          <p:cNvSpPr txBox="1"/>
          <p:nvPr/>
        </p:nvSpPr>
        <p:spPr>
          <a:xfrm>
            <a:off x="7125130" y="4079842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2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E5BED53-AFA7-8D92-DE98-9A252033B368}"/>
              </a:ext>
            </a:extLst>
          </p:cNvPr>
          <p:cNvSpPr txBox="1"/>
          <p:nvPr/>
        </p:nvSpPr>
        <p:spPr>
          <a:xfrm>
            <a:off x="7125129" y="4635653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1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120688B-0A9C-C585-B8CD-AE5B1CD383D8}"/>
              </a:ext>
            </a:extLst>
          </p:cNvPr>
          <p:cNvSpPr txBox="1"/>
          <p:nvPr/>
        </p:nvSpPr>
        <p:spPr>
          <a:xfrm>
            <a:off x="7125130" y="5003211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1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DE60BD0-D2D6-E51E-0EE4-34D734ABD4DC}"/>
              </a:ext>
            </a:extLst>
          </p:cNvPr>
          <p:cNvSpPr txBox="1"/>
          <p:nvPr/>
        </p:nvSpPr>
        <p:spPr>
          <a:xfrm>
            <a:off x="7005458" y="484986"/>
            <a:ext cx="50526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u="sng" dirty="0"/>
              <a:t>MW</a:t>
            </a:r>
          </a:p>
          <a:p>
            <a:pPr algn="ctr"/>
            <a:r>
              <a:rPr lang="en-US" sz="1400" b="1" u="sng" dirty="0" err="1"/>
              <a:t>kDa</a:t>
            </a:r>
            <a:endParaRPr lang="en-US" sz="1400" b="1" u="sng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1CA7904-475C-103D-0B90-1DE95738EEE6}"/>
              </a:ext>
            </a:extLst>
          </p:cNvPr>
          <p:cNvSpPr txBox="1"/>
          <p:nvPr/>
        </p:nvSpPr>
        <p:spPr>
          <a:xfrm>
            <a:off x="5078507" y="286870"/>
            <a:ext cx="2888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48EF48C-419B-5883-2BB6-68B28A2509E8}"/>
              </a:ext>
            </a:extLst>
          </p:cNvPr>
          <p:cNvSpPr txBox="1"/>
          <p:nvPr/>
        </p:nvSpPr>
        <p:spPr>
          <a:xfrm>
            <a:off x="5822578" y="286870"/>
            <a:ext cx="2888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2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920731B-267F-A7CB-4AE2-B49859341B71}"/>
              </a:ext>
            </a:extLst>
          </p:cNvPr>
          <p:cNvSpPr txBox="1"/>
          <p:nvPr/>
        </p:nvSpPr>
        <p:spPr>
          <a:xfrm>
            <a:off x="6468037" y="286871"/>
            <a:ext cx="2888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3</a:t>
            </a: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42E96012-3D02-C72B-0F47-F2F91F73CBEB}"/>
              </a:ext>
            </a:extLst>
          </p:cNvPr>
          <p:cNvCxnSpPr/>
          <p:nvPr/>
        </p:nvCxnSpPr>
        <p:spPr>
          <a:xfrm>
            <a:off x="4940915" y="286870"/>
            <a:ext cx="192991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63397479-A340-FE66-3360-BE6038877146}"/>
              </a:ext>
            </a:extLst>
          </p:cNvPr>
          <p:cNvSpPr txBox="1"/>
          <p:nvPr/>
        </p:nvSpPr>
        <p:spPr>
          <a:xfrm>
            <a:off x="5625352" y="0"/>
            <a:ext cx="6671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Lane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CD940FD-8DE1-F06A-A9A2-72929371B97D}"/>
              </a:ext>
            </a:extLst>
          </p:cNvPr>
          <p:cNvSpPr txBox="1"/>
          <p:nvPr/>
        </p:nvSpPr>
        <p:spPr>
          <a:xfrm>
            <a:off x="2376409" y="5507438"/>
            <a:ext cx="7712817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Supplemental Figure 1</a:t>
            </a:r>
          </a:p>
          <a:p>
            <a:r>
              <a:rPr lang="en-US" sz="1400" dirty="0"/>
              <a:t>SDS-PAGE of 4ug of Xyl3C (lane 1) and Xyl3B (lane 2). Preparations Xyl3B and Xyl3C were quantified </a:t>
            </a:r>
          </a:p>
          <a:p>
            <a:r>
              <a:rPr lang="en-US" sz="1400" dirty="0"/>
              <a:t>by 280 nm using </a:t>
            </a:r>
            <a:r>
              <a:rPr lang="en-US" sz="1400" dirty="0" err="1"/>
              <a:t>ProtParam</a:t>
            </a:r>
            <a:r>
              <a:rPr lang="en-US" sz="1400" dirty="0"/>
              <a:t> predicted extinction coefficients following IMAC purification and desalting. </a:t>
            </a:r>
          </a:p>
          <a:p>
            <a:r>
              <a:rPr lang="en-US" sz="1400" dirty="0"/>
              <a:t>Lane 3 contains SDS-PAGE molecular weight (MW) standards.</a:t>
            </a:r>
          </a:p>
        </p:txBody>
      </p:sp>
    </p:spTree>
    <p:extLst>
      <p:ext uri="{BB962C8B-B14F-4D97-AF65-F5344CB8AC3E}">
        <p14:creationId xmlns:p14="http://schemas.microsoft.com/office/powerpoint/2010/main" val="3603194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31618D2-296B-2D75-E68B-73913F3D395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2252" y="369332"/>
            <a:ext cx="3780708" cy="593322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BFD61D8-646B-A0D8-E36B-FCB48938193E}"/>
              </a:ext>
            </a:extLst>
          </p:cNvPr>
          <p:cNvSpPr txBox="1"/>
          <p:nvPr/>
        </p:nvSpPr>
        <p:spPr>
          <a:xfrm>
            <a:off x="3556753" y="6302753"/>
            <a:ext cx="5405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/>
              <a:t>XUXX</a:t>
            </a:r>
          </a:p>
          <a:p>
            <a:pPr algn="ctr"/>
            <a:r>
              <a:rPr lang="en-US" sz="1200" b="1" dirty="0"/>
              <a:t>ctr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37947C7-9ED6-BFB3-A5DB-C3B5CD3801D2}"/>
              </a:ext>
            </a:extLst>
          </p:cNvPr>
          <p:cNvSpPr txBox="1"/>
          <p:nvPr/>
        </p:nvSpPr>
        <p:spPr>
          <a:xfrm>
            <a:off x="4494951" y="6302753"/>
            <a:ext cx="5036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/>
              <a:t>X</a:t>
            </a:r>
            <a:r>
              <a:rPr lang="en-US" sz="1200" b="1" baseline="-25000" dirty="0"/>
              <a:t>1</a:t>
            </a:r>
            <a:r>
              <a:rPr lang="en-US" sz="1200" b="1" dirty="0"/>
              <a:t>-X</a:t>
            </a:r>
            <a:r>
              <a:rPr lang="en-US" sz="1200" b="1" baseline="-25000" dirty="0"/>
              <a:t>6</a:t>
            </a:r>
            <a:endParaRPr lang="en-US" sz="1200" b="1" dirty="0"/>
          </a:p>
          <a:p>
            <a:pPr algn="ctr"/>
            <a:r>
              <a:rPr lang="en-US" sz="1200" b="1" dirty="0"/>
              <a:t>st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4BC0742-B51F-F5E3-84CF-144BFE777E43}"/>
              </a:ext>
            </a:extLst>
          </p:cNvPr>
          <p:cNvSpPr txBox="1"/>
          <p:nvPr/>
        </p:nvSpPr>
        <p:spPr>
          <a:xfrm>
            <a:off x="2469087" y="6302753"/>
            <a:ext cx="8273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XUXX</a:t>
            </a:r>
          </a:p>
          <a:p>
            <a:pPr algn="ctr"/>
            <a:r>
              <a:rPr lang="en-US" sz="1200" b="1" dirty="0"/>
              <a:t>Xyl3C </a:t>
            </a:r>
            <a:r>
              <a:rPr lang="en-US" sz="1200" b="1" dirty="0" err="1"/>
              <a:t>rxn</a:t>
            </a:r>
            <a:endParaRPr lang="en-US" sz="12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B9EBB5F-69B6-0807-C7D9-29FB449B104C}"/>
              </a:ext>
            </a:extLst>
          </p:cNvPr>
          <p:cNvSpPr txBox="1"/>
          <p:nvPr/>
        </p:nvSpPr>
        <p:spPr>
          <a:xfrm>
            <a:off x="1389721" y="6302753"/>
            <a:ext cx="8273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XUXX</a:t>
            </a:r>
          </a:p>
          <a:p>
            <a:pPr algn="ctr"/>
            <a:r>
              <a:rPr lang="en-US" sz="1200" b="1" dirty="0"/>
              <a:t>Xyl3B </a:t>
            </a:r>
            <a:r>
              <a:rPr lang="en-US" sz="1200" b="1" dirty="0" err="1"/>
              <a:t>rxn</a:t>
            </a:r>
            <a:endParaRPr lang="en-US" sz="12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8BBBCB3-7683-C041-C559-C7A244EE5785}"/>
              </a:ext>
            </a:extLst>
          </p:cNvPr>
          <p:cNvSpPr txBox="1"/>
          <p:nvPr/>
        </p:nvSpPr>
        <p:spPr>
          <a:xfrm>
            <a:off x="5145086" y="1334057"/>
            <a:ext cx="408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err="1"/>
              <a:t>Xyl</a:t>
            </a:r>
            <a:endParaRPr lang="en-US" sz="1400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6F69C60-2B81-85BB-1339-D3D81C60A573}"/>
              </a:ext>
            </a:extLst>
          </p:cNvPr>
          <p:cNvSpPr txBox="1"/>
          <p:nvPr/>
        </p:nvSpPr>
        <p:spPr>
          <a:xfrm>
            <a:off x="5143515" y="2991410"/>
            <a:ext cx="3449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X</a:t>
            </a:r>
            <a:r>
              <a:rPr lang="en-US" sz="1400" b="1" baseline="-25000" dirty="0"/>
              <a:t>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32E8B78-B0E3-51EB-9CFD-4B0B690F0B32}"/>
              </a:ext>
            </a:extLst>
          </p:cNvPr>
          <p:cNvSpPr txBox="1"/>
          <p:nvPr/>
        </p:nvSpPr>
        <p:spPr>
          <a:xfrm>
            <a:off x="5141057" y="4183263"/>
            <a:ext cx="3449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X</a:t>
            </a:r>
            <a:r>
              <a:rPr lang="en-US" sz="1400" b="1" baseline="-25000" dirty="0"/>
              <a:t>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422240D-7D7D-9542-7E0B-4F2105BC766A}"/>
              </a:ext>
            </a:extLst>
          </p:cNvPr>
          <p:cNvSpPr txBox="1"/>
          <p:nvPr/>
        </p:nvSpPr>
        <p:spPr>
          <a:xfrm>
            <a:off x="5141058" y="4952330"/>
            <a:ext cx="3449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X</a:t>
            </a:r>
            <a:r>
              <a:rPr lang="en-US" sz="1400" b="1" baseline="-25000" dirty="0"/>
              <a:t>4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7064DB1-F56B-EE4F-9A76-35A9DEE6B47A}"/>
              </a:ext>
            </a:extLst>
          </p:cNvPr>
          <p:cNvSpPr txBox="1"/>
          <p:nvPr/>
        </p:nvSpPr>
        <p:spPr>
          <a:xfrm>
            <a:off x="5141058" y="5361907"/>
            <a:ext cx="3449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X</a:t>
            </a:r>
            <a:r>
              <a:rPr lang="en-US" sz="1400" b="1" baseline="-25000" dirty="0"/>
              <a:t>5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0A89BA1-024B-B82B-47C2-BD233AA3D622}"/>
              </a:ext>
            </a:extLst>
          </p:cNvPr>
          <p:cNvSpPr txBox="1"/>
          <p:nvPr/>
        </p:nvSpPr>
        <p:spPr>
          <a:xfrm>
            <a:off x="5138601" y="5575144"/>
            <a:ext cx="3449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X</a:t>
            </a:r>
            <a:r>
              <a:rPr lang="en-US" sz="1400" b="1" baseline="-25000" dirty="0"/>
              <a:t>6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CE35409-D4BB-ED82-9C82-13B2A1F89AFD}"/>
              </a:ext>
            </a:extLst>
          </p:cNvPr>
          <p:cNvCxnSpPr/>
          <p:nvPr/>
        </p:nvCxnSpPr>
        <p:spPr>
          <a:xfrm>
            <a:off x="2481126" y="1497470"/>
            <a:ext cx="2724150" cy="0"/>
          </a:xfrm>
          <a:prstGeom prst="line">
            <a:avLst/>
          </a:prstGeom>
          <a:ln w="1587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4FDD7B53-CDAE-9D2A-889E-A6B6B9102AA4}"/>
              </a:ext>
            </a:extLst>
          </p:cNvPr>
          <p:cNvCxnSpPr/>
          <p:nvPr/>
        </p:nvCxnSpPr>
        <p:spPr>
          <a:xfrm>
            <a:off x="4420206" y="4326395"/>
            <a:ext cx="789091" cy="0"/>
          </a:xfrm>
          <a:prstGeom prst="line">
            <a:avLst/>
          </a:prstGeom>
          <a:ln w="1587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507844A2-0991-9BAC-D37A-9AFA24C394D6}"/>
              </a:ext>
            </a:extLst>
          </p:cNvPr>
          <p:cNvCxnSpPr/>
          <p:nvPr/>
        </p:nvCxnSpPr>
        <p:spPr>
          <a:xfrm>
            <a:off x="4420207" y="3145295"/>
            <a:ext cx="789089" cy="0"/>
          </a:xfrm>
          <a:prstGeom prst="line">
            <a:avLst/>
          </a:prstGeom>
          <a:ln w="1587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77387370-9A87-9366-7C84-8ED40895069B}"/>
              </a:ext>
            </a:extLst>
          </p:cNvPr>
          <p:cNvCxnSpPr/>
          <p:nvPr/>
        </p:nvCxnSpPr>
        <p:spPr>
          <a:xfrm>
            <a:off x="4420207" y="5107445"/>
            <a:ext cx="789089" cy="0"/>
          </a:xfrm>
          <a:prstGeom prst="line">
            <a:avLst/>
          </a:prstGeom>
          <a:ln w="1587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C157F2DC-0060-93F0-E2CD-65DB29807236}"/>
              </a:ext>
            </a:extLst>
          </p:cNvPr>
          <p:cNvCxnSpPr/>
          <p:nvPr/>
        </p:nvCxnSpPr>
        <p:spPr>
          <a:xfrm>
            <a:off x="4429732" y="5507495"/>
            <a:ext cx="789089" cy="0"/>
          </a:xfrm>
          <a:prstGeom prst="line">
            <a:avLst/>
          </a:prstGeom>
          <a:ln w="1587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1CE89EB7-AD54-FD82-F0C1-F5D7A0507ACE}"/>
              </a:ext>
            </a:extLst>
          </p:cNvPr>
          <p:cNvCxnSpPr/>
          <p:nvPr/>
        </p:nvCxnSpPr>
        <p:spPr>
          <a:xfrm>
            <a:off x="4429732" y="5726570"/>
            <a:ext cx="789089" cy="0"/>
          </a:xfrm>
          <a:prstGeom prst="line">
            <a:avLst/>
          </a:prstGeom>
          <a:ln w="1587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330C1E5F-EFA9-A3A1-CE91-92EDB282C0A8}"/>
              </a:ext>
            </a:extLst>
          </p:cNvPr>
          <p:cNvSpPr txBox="1"/>
          <p:nvPr/>
        </p:nvSpPr>
        <p:spPr>
          <a:xfrm>
            <a:off x="851195" y="5266655"/>
            <a:ext cx="5998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XUXX</a:t>
            </a: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5D85ED85-B443-E8D1-6D26-DECC38C52EEB}"/>
              </a:ext>
            </a:extLst>
          </p:cNvPr>
          <p:cNvCxnSpPr/>
          <p:nvPr/>
        </p:nvCxnSpPr>
        <p:spPr>
          <a:xfrm>
            <a:off x="1385750" y="5412245"/>
            <a:ext cx="2724152" cy="0"/>
          </a:xfrm>
          <a:prstGeom prst="line">
            <a:avLst/>
          </a:prstGeom>
          <a:ln w="15875">
            <a:solidFill>
              <a:schemeClr val="bg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62BA2ED4-E34F-B8A6-26BA-44507415C568}"/>
              </a:ext>
            </a:extLst>
          </p:cNvPr>
          <p:cNvSpPr txBox="1"/>
          <p:nvPr/>
        </p:nvSpPr>
        <p:spPr>
          <a:xfrm>
            <a:off x="948513" y="4847555"/>
            <a:ext cx="5004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UXX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D39A56A2-8661-9425-874F-6A5901897342}"/>
              </a:ext>
            </a:extLst>
          </p:cNvPr>
          <p:cNvCxnSpPr/>
          <p:nvPr/>
        </p:nvCxnSpPr>
        <p:spPr>
          <a:xfrm>
            <a:off x="1385750" y="5002670"/>
            <a:ext cx="2724152" cy="0"/>
          </a:xfrm>
          <a:prstGeom prst="line">
            <a:avLst/>
          </a:prstGeom>
          <a:ln w="15875">
            <a:solidFill>
              <a:schemeClr val="bg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ADADF9EC-B4EE-4DF3-FF5C-CA63544A67BB}"/>
              </a:ext>
            </a:extLst>
          </p:cNvPr>
          <p:cNvSpPr txBox="1"/>
          <p:nvPr/>
        </p:nvSpPr>
        <p:spPr>
          <a:xfrm>
            <a:off x="89762" y="0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2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D62CBD3-BE7C-CF54-07CD-F47FC2CA078D}"/>
              </a:ext>
            </a:extLst>
          </p:cNvPr>
          <p:cNvSpPr txBox="1"/>
          <p:nvPr/>
        </p:nvSpPr>
        <p:spPr>
          <a:xfrm>
            <a:off x="6029770" y="5364034"/>
            <a:ext cx="5127494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Supplemental Figure 2</a:t>
            </a:r>
          </a:p>
          <a:p>
            <a:r>
              <a:rPr lang="en-US" sz="1400" dirty="0"/>
              <a:t>TLC analysis of Xyl3B hydrolysis of XUXX (Lane 1) next to a control </a:t>
            </a:r>
          </a:p>
          <a:p>
            <a:r>
              <a:rPr lang="en-US" sz="1400" dirty="0"/>
              <a:t>reaction showing the hydrolysis of XUXX by Xyl3C (Lane 2). Xyl3B </a:t>
            </a:r>
          </a:p>
          <a:p>
            <a:r>
              <a:rPr lang="en-US" sz="1400" dirty="0"/>
              <a:t>does not release xylose from the reducing terminus of XUXX like </a:t>
            </a:r>
          </a:p>
          <a:p>
            <a:r>
              <a:rPr lang="en-US" sz="1400" dirty="0"/>
              <a:t>what is known for Xyl3C. </a:t>
            </a:r>
            <a:r>
              <a:rPr lang="en-US" sz="1400" dirty="0" err="1"/>
              <a:t>Xyl</a:t>
            </a:r>
            <a:r>
              <a:rPr lang="en-US" sz="1400" dirty="0"/>
              <a:t> = xylose, X</a:t>
            </a:r>
            <a:r>
              <a:rPr lang="en-US" sz="1400" baseline="-25000" dirty="0"/>
              <a:t>2</a:t>
            </a:r>
            <a:r>
              <a:rPr lang="en-US" sz="1400" dirty="0"/>
              <a:t> - X</a:t>
            </a:r>
            <a:r>
              <a:rPr lang="en-US" sz="1400" baseline="-25000" dirty="0"/>
              <a:t>6</a:t>
            </a:r>
            <a:r>
              <a:rPr lang="en-US" sz="1400" dirty="0"/>
              <a:t> = linear </a:t>
            </a:r>
            <a:r>
              <a:rPr lang="en-US" sz="1400" dirty="0" err="1"/>
              <a:t>oligoxylosides</a:t>
            </a:r>
            <a:r>
              <a:rPr lang="en-US" sz="14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6017967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5</TotalTime>
  <Words>153</Words>
  <Application>Microsoft Office PowerPoint</Application>
  <PresentationFormat>Widescreen</PresentationFormat>
  <Paragraphs>4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 john, Franz - FS, WI</dc:creator>
  <cp:lastModifiedBy>St john, Franz -FS</cp:lastModifiedBy>
  <cp:revision>9</cp:revision>
  <cp:lastPrinted>2024-05-07T20:33:10Z</cp:lastPrinted>
  <dcterms:created xsi:type="dcterms:W3CDTF">2023-07-17T18:50:16Z</dcterms:created>
  <dcterms:modified xsi:type="dcterms:W3CDTF">2024-05-31T19:02:19Z</dcterms:modified>
</cp:coreProperties>
</file>